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7EA5"/>
    <a:srgbClr val="036E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108" y="186"/>
      </p:cViewPr>
      <p:guideLst>
        <p:guide orient="horz" pos="2205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A7B755-36E2-4A39-B0FA-302D7A5F31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7F5B0C7-EC96-4CB6-BBF4-E961080FFA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2E2F8E-092D-4569-BDE1-145E13422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2248EBD-C404-41AB-8520-1E140CA10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7C08FA-B442-4750-88C0-A358BC860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2262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6EB957-C1BF-4653-BC31-1AD41B95E0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3F3102F-9B11-4033-92FC-B02F17F785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1280DA6-4B95-4AA6-95D8-6C1D71315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6C7BC81-E000-4C27-BE7F-0A089D06C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7590EF4-B347-4CF4-B275-9DBFD4C96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8140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2791244-32E8-40D4-A184-BCA82DDA68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7313F5A-0C95-4C85-A239-8639C2D7F1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62E6E3C-53A0-464D-8787-5C128CC36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04FCC60-175E-4DBF-AC0C-9E61C8684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A8542C6-5782-425C-9A51-94EB8912D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4978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004D19-A9DC-4A9A-B99C-9B814D601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33AACA1-3112-4253-B5A5-0FE863FBC0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509E745-D97E-436C-951A-A30CA4377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3722DE2-37E4-492D-8137-21BFAAD99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829982-7CE3-4654-A932-31250C8B3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4020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8C249B-8767-4E21-8813-522D729E6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0F63C8D-B1C4-4B2F-AD22-D70BE10EC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F26CAD9-A71D-43C1-AC71-FF758513B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47083CF-7C13-4A7D-A87E-628E74130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0917841-B180-44DE-892B-8C78ABF24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2865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C7C7BD-97E3-4C7B-BBA7-72A08A220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FD43472-9885-4F60-9795-B5E72DA61F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C421E98-10D7-4F43-8A12-44C8F7A2A7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4261BB4-9781-4613-8915-2D84C2476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05512FC-EC13-463C-A780-08170AFA5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13304D4-1176-4C25-86B8-56D1C64FB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008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A207DF-42C4-4615-BCAE-BE277C20B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8EE02DB-7303-498E-8E47-24C1CA1651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E37BE4F-31C5-4E7F-8170-B210A1F885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4EAD426-9241-4B0A-A27F-3438A5B447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ED95F3D-D72C-4776-B295-C35E3A591C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0EBC751-5C35-4E78-8D33-6A5EA92D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8883DF7-1272-4933-95EE-BD1078FC3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C4B9C2B-36EC-413E-BD5C-45670BD22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28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51B4A3-A2FF-4712-A6E7-9E29C248A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61957EDE-8A6F-449F-8F8C-B0145F018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D29645C-1A94-4EBD-8899-937B03C73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BD2D42B-83E3-498D-B2E0-B27375F62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0648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BDF17A5-09A8-47F0-8CB8-E71CACE46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E82CA39-DE71-4AE3-B3B0-2DCEAB59A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3AF4A19-5222-4995-83DF-693156341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09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C4BF3A-645E-4629-B527-E3431DFC55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30D8A6D-5754-418F-90F4-DE847073AE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875FBB0-E391-4694-9D05-D7E9149307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379E0BE-7551-4B32-883E-FBA0B64CE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444F5EA-68A8-4C09-9DF4-772450CAA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064B799-A1BE-4557-B4E8-5B8CDA685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3385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F548A1-6B89-4351-B77D-179F082C0D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4D6C148-DCD2-46E4-84AB-5146782019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54C6760-A7F3-454B-99A7-6115D244DB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4665166-15C5-4D05-9452-668DA0D24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24A32EA-B314-4502-807F-1B7134AEF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A451D16-2A66-4431-B62B-2D62D1F00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489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E9CDC2F-89F2-4F32-84AE-949E6AF62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09320F-8D6D-410C-BA0C-8A64423C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B56474-D0D1-46BD-9AA6-A00C949369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3F013-1D11-403E-9F39-C57F6684381E}" type="datetimeFigureOut">
              <a:rPr lang="de-DE" smtClean="0"/>
              <a:t>07.02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A65C70-0559-411E-8BCB-8761C61561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A0E267-F447-41ED-89AD-030BFB51AA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5812E1-E1EC-4584-A9EA-642A88D773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6380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png"/><Relationship Id="rId12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5.tiff"/><Relationship Id="rId10" Type="http://schemas.openxmlformats.org/officeDocument/2006/relationships/image" Target="../media/image1.emf"/><Relationship Id="rId4" Type="http://schemas.openxmlformats.org/officeDocument/2006/relationships/image" Target="../media/image4.tiff"/><Relationship Id="rId9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Grafik 18">
            <a:extLst>
              <a:ext uri="{FF2B5EF4-FFF2-40B4-BE49-F238E27FC236}">
                <a16:creationId xmlns:a16="http://schemas.microsoft.com/office/drawing/2014/main" id="{0C4939A3-D818-4375-AD4F-1A1E3EDAE45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24" t="36252" r="15002" b="8981"/>
          <a:stretch/>
        </p:blipFill>
        <p:spPr>
          <a:xfrm>
            <a:off x="10168421" y="463267"/>
            <a:ext cx="1714373" cy="1817307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2265309C-A21E-4F3A-80D0-C40E788B842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067595" y="3536668"/>
            <a:ext cx="1570079" cy="4250348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F5C33928-F0C1-4911-92AA-1A31F772227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15" t="4113" r="20244" b="3300"/>
          <a:stretch/>
        </p:blipFill>
        <p:spPr>
          <a:xfrm>
            <a:off x="223817" y="2673390"/>
            <a:ext cx="2830737" cy="3736050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B1C00425-0D51-42A8-9944-F4C90AF36AE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514" y="517779"/>
            <a:ext cx="1223064" cy="1706536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422B8C6D-3319-4B25-A7D1-36C2A2C6737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27" t="62731"/>
          <a:stretch/>
        </p:blipFill>
        <p:spPr>
          <a:xfrm>
            <a:off x="2509224" y="1132870"/>
            <a:ext cx="897006" cy="725389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AFB1896E-D380-4FCE-B019-83123598A47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159" r="75435"/>
          <a:stretch/>
        </p:blipFill>
        <p:spPr>
          <a:xfrm>
            <a:off x="1759263" y="578038"/>
            <a:ext cx="373856" cy="1281095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45376E1E-B97D-4CD6-8912-7469D89ED87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22" r="18912" b="48080"/>
          <a:stretch/>
        </p:blipFill>
        <p:spPr>
          <a:xfrm>
            <a:off x="2050083" y="635149"/>
            <a:ext cx="515413" cy="1223110"/>
          </a:xfrm>
          <a:prstGeom prst="rect">
            <a:avLst/>
          </a:prstGeom>
        </p:spPr>
      </p:pic>
      <p:sp>
        <p:nvSpPr>
          <p:cNvPr id="9" name="Rechteck: abgerundete Ecken 8">
            <a:extLst>
              <a:ext uri="{FF2B5EF4-FFF2-40B4-BE49-F238E27FC236}">
                <a16:creationId xmlns:a16="http://schemas.microsoft.com/office/drawing/2014/main" id="{F652B93F-6DE1-4953-995F-031027BE724E}"/>
              </a:ext>
            </a:extLst>
          </p:cNvPr>
          <p:cNvSpPr/>
          <p:nvPr/>
        </p:nvSpPr>
        <p:spPr>
          <a:xfrm>
            <a:off x="3219800" y="2548875"/>
            <a:ext cx="5235087" cy="3940077"/>
          </a:xfrm>
          <a:prstGeom prst="roundRect">
            <a:avLst/>
          </a:prstGeom>
          <a:noFill/>
          <a:ln w="57150">
            <a:solidFill>
              <a:srgbClr val="037E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Rechteck: abgerundete Ecken 9">
            <a:extLst>
              <a:ext uri="{FF2B5EF4-FFF2-40B4-BE49-F238E27FC236}">
                <a16:creationId xmlns:a16="http://schemas.microsoft.com/office/drawing/2014/main" id="{C73511B5-0818-4195-B6EC-9305FC6F73A4}"/>
              </a:ext>
            </a:extLst>
          </p:cNvPr>
          <p:cNvSpPr/>
          <p:nvPr/>
        </p:nvSpPr>
        <p:spPr>
          <a:xfrm>
            <a:off x="8617788" y="2548875"/>
            <a:ext cx="3335673" cy="3940077"/>
          </a:xfrm>
          <a:prstGeom prst="roundRect">
            <a:avLst/>
          </a:prstGeom>
          <a:noFill/>
          <a:ln w="57150">
            <a:solidFill>
              <a:srgbClr val="037E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1" name="Rechteck: abgerundete Ecken 10">
            <a:extLst>
              <a:ext uri="{FF2B5EF4-FFF2-40B4-BE49-F238E27FC236}">
                <a16:creationId xmlns:a16="http://schemas.microsoft.com/office/drawing/2014/main" id="{C1F1D0CA-8451-4759-8CD0-5BDD691433C1}"/>
              </a:ext>
            </a:extLst>
          </p:cNvPr>
          <p:cNvSpPr/>
          <p:nvPr/>
        </p:nvSpPr>
        <p:spPr>
          <a:xfrm>
            <a:off x="220554" y="2548875"/>
            <a:ext cx="2836345" cy="3940077"/>
          </a:xfrm>
          <a:prstGeom prst="roundRect">
            <a:avLst/>
          </a:prstGeom>
          <a:noFill/>
          <a:ln w="57150">
            <a:solidFill>
              <a:srgbClr val="037E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Rechteck: abgerundete Ecken 14">
            <a:extLst>
              <a:ext uri="{FF2B5EF4-FFF2-40B4-BE49-F238E27FC236}">
                <a16:creationId xmlns:a16="http://schemas.microsoft.com/office/drawing/2014/main" id="{FB24D884-AEF6-42B3-9382-07CC28A46401}"/>
              </a:ext>
            </a:extLst>
          </p:cNvPr>
          <p:cNvSpPr/>
          <p:nvPr/>
        </p:nvSpPr>
        <p:spPr>
          <a:xfrm>
            <a:off x="220554" y="424374"/>
            <a:ext cx="11732907" cy="1898894"/>
          </a:xfrm>
          <a:prstGeom prst="roundRect">
            <a:avLst/>
          </a:prstGeom>
          <a:noFill/>
          <a:ln w="57150">
            <a:solidFill>
              <a:srgbClr val="037EA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7" name="Pfeil: nach rechts 26">
            <a:extLst>
              <a:ext uri="{FF2B5EF4-FFF2-40B4-BE49-F238E27FC236}">
                <a16:creationId xmlns:a16="http://schemas.microsoft.com/office/drawing/2014/main" id="{A025F685-A150-400B-BFE2-37C1BDF1D9F5}"/>
              </a:ext>
            </a:extLst>
          </p:cNvPr>
          <p:cNvSpPr/>
          <p:nvPr/>
        </p:nvSpPr>
        <p:spPr>
          <a:xfrm>
            <a:off x="3590515" y="1134992"/>
            <a:ext cx="671601" cy="473320"/>
          </a:xfrm>
          <a:prstGeom prst="rightArrow">
            <a:avLst>
              <a:gd name="adj1" fmla="val 50000"/>
              <a:gd name="adj2" fmla="val 72856"/>
            </a:avLst>
          </a:prstGeom>
          <a:solidFill>
            <a:srgbClr val="037EA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83F27707-776B-498D-AC27-517E4A73408A}"/>
              </a:ext>
            </a:extLst>
          </p:cNvPr>
          <p:cNvSpPr txBox="1"/>
          <p:nvPr/>
        </p:nvSpPr>
        <p:spPr>
          <a:xfrm>
            <a:off x="1659236" y="1880352"/>
            <a:ext cx="1803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Verdana" panose="020B0604030504040204" pitchFamily="34" charset="0"/>
                <a:ea typeface="Verdana" panose="020B0604030504040204" pitchFamily="34" charset="0"/>
              </a:rPr>
              <a:t>Collecting</a:t>
            </a:r>
            <a:r>
              <a:rPr lang="de-DE" sz="1200" b="1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b="1" dirty="0" err="1">
                <a:latin typeface="Verdana" panose="020B0604030504040204" pitchFamily="34" charset="0"/>
                <a:ea typeface="Verdana" panose="020B0604030504040204" pitchFamily="34" charset="0"/>
              </a:rPr>
              <a:t>samples</a:t>
            </a:r>
            <a:endParaRPr lang="de-DE" sz="1200" b="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B661764-EC15-4D45-AD22-F16A0DA5B1AB}"/>
              </a:ext>
            </a:extLst>
          </p:cNvPr>
          <p:cNvSpPr txBox="1"/>
          <p:nvPr/>
        </p:nvSpPr>
        <p:spPr>
          <a:xfrm>
            <a:off x="4212549" y="694756"/>
            <a:ext cx="1539139" cy="10926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200" b="1" dirty="0">
                <a:latin typeface="Verdana" panose="020B0604030504040204" pitchFamily="34" charset="0"/>
                <a:ea typeface="Verdana" panose="020B0604030504040204" pitchFamily="34" charset="0"/>
              </a:rPr>
              <a:t>Analysis</a:t>
            </a:r>
          </a:p>
          <a:p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eripheral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blood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 </a:t>
            </a:r>
          </a:p>
          <a:p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Primary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tumor</a:t>
            </a:r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D53761C-9BBF-441D-8F02-7DF2706873C6}"/>
              </a:ext>
            </a:extLst>
          </p:cNvPr>
          <p:cNvSpPr txBox="1"/>
          <p:nvPr/>
        </p:nvSpPr>
        <p:spPr>
          <a:xfrm>
            <a:off x="5629730" y="935383"/>
            <a:ext cx="291137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Expression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rofiles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of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immune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cells</a:t>
            </a:r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Soluble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factors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in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atients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lasma</a:t>
            </a:r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Expression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rofiles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of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tumor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cells</a:t>
            </a:r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Expression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profiles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of</a:t>
            </a:r>
            <a:r>
              <a:rPr lang="de-DE" sz="1200" dirty="0">
                <a:latin typeface="Verdana" panose="020B0604030504040204" pitchFamily="34" charset="0"/>
                <a:ea typeface="Verdana" panose="020B0604030504040204" pitchFamily="34" charset="0"/>
              </a:rPr>
              <a:t> TILs</a:t>
            </a:r>
          </a:p>
        </p:txBody>
      </p:sp>
      <p:sp>
        <p:nvSpPr>
          <p:cNvPr id="33" name="Pfeil: nach rechts 32">
            <a:extLst>
              <a:ext uri="{FF2B5EF4-FFF2-40B4-BE49-F238E27FC236}">
                <a16:creationId xmlns:a16="http://schemas.microsoft.com/office/drawing/2014/main" id="{B55B37EC-069F-4F84-91DA-9625F983F48B}"/>
              </a:ext>
            </a:extLst>
          </p:cNvPr>
          <p:cNvSpPr/>
          <p:nvPr/>
        </p:nvSpPr>
        <p:spPr>
          <a:xfrm>
            <a:off x="8543943" y="1132870"/>
            <a:ext cx="628006" cy="473320"/>
          </a:xfrm>
          <a:prstGeom prst="rightArrow">
            <a:avLst>
              <a:gd name="adj1" fmla="val 50000"/>
              <a:gd name="adj2" fmla="val 72856"/>
            </a:avLst>
          </a:prstGeom>
          <a:solidFill>
            <a:srgbClr val="037EA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43C40394-62E3-48CA-99F6-0122B0423047}"/>
              </a:ext>
            </a:extLst>
          </p:cNvPr>
          <p:cNvSpPr txBox="1"/>
          <p:nvPr/>
        </p:nvSpPr>
        <p:spPr>
          <a:xfrm>
            <a:off x="9108856" y="1146938"/>
            <a:ext cx="1172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>
                <a:latin typeface="Verdana" panose="020B0604030504040204" pitchFamily="34" charset="0"/>
                <a:ea typeface="Verdana" panose="020B0604030504040204" pitchFamily="34" charset="0"/>
              </a:rPr>
              <a:t>Identifying</a:t>
            </a:r>
            <a:endParaRPr lang="de-DE" sz="1200" b="1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pPr algn="ctr"/>
            <a:r>
              <a:rPr lang="de-DE" sz="1200" b="1" dirty="0">
                <a:latin typeface="Verdana" panose="020B0604030504040204" pitchFamily="34" charset="0"/>
                <a:ea typeface="Verdana" panose="020B0604030504040204" pitchFamily="34" charset="0"/>
              </a:rPr>
              <a:t>Scoring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ED47E4EC-16D7-4F91-84FC-8E6CF111A2F8}"/>
              </a:ext>
            </a:extLst>
          </p:cNvPr>
          <p:cNvSpPr txBox="1"/>
          <p:nvPr/>
        </p:nvSpPr>
        <p:spPr>
          <a:xfrm>
            <a:off x="11332433" y="799770"/>
            <a:ext cx="497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100" b="1" dirty="0">
                <a:latin typeface="Verdana" panose="020B0604030504040204" pitchFamily="34" charset="0"/>
                <a:ea typeface="Verdana" panose="020B0604030504040204" pitchFamily="34" charset="0"/>
              </a:rPr>
              <a:t>CR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B8F7FB1-E624-4C3A-9487-901B0FE7EFA4}"/>
              </a:ext>
            </a:extLst>
          </p:cNvPr>
          <p:cNvSpPr txBox="1"/>
          <p:nvPr/>
        </p:nvSpPr>
        <p:spPr>
          <a:xfrm>
            <a:off x="10824272" y="858523"/>
            <a:ext cx="497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100" b="1" dirty="0">
                <a:latin typeface="Verdana" panose="020B0604030504040204" pitchFamily="34" charset="0"/>
                <a:ea typeface="Verdana" panose="020B0604030504040204" pitchFamily="34" charset="0"/>
              </a:rPr>
              <a:t>PR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9C482688-EDCB-4476-9B1D-04D065FACA30}"/>
              </a:ext>
            </a:extLst>
          </p:cNvPr>
          <p:cNvSpPr txBox="1"/>
          <p:nvPr/>
        </p:nvSpPr>
        <p:spPr>
          <a:xfrm>
            <a:off x="10224533" y="1066843"/>
            <a:ext cx="497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100" b="1" dirty="0">
                <a:latin typeface="Verdana" panose="020B0604030504040204" pitchFamily="34" charset="0"/>
                <a:ea typeface="Verdana" panose="020B0604030504040204" pitchFamily="34" charset="0"/>
              </a:rPr>
              <a:t>NR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217DEA5D-CB31-4B30-862D-F70B326894D5}"/>
              </a:ext>
            </a:extLst>
          </p:cNvPr>
          <p:cNvSpPr txBox="1"/>
          <p:nvPr/>
        </p:nvSpPr>
        <p:spPr>
          <a:xfrm>
            <a:off x="3457201" y="5386360"/>
            <a:ext cx="1510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400" b="1" dirty="0" err="1">
                <a:latin typeface="Verdana" panose="020B0604030504040204" pitchFamily="34" charset="0"/>
                <a:ea typeface="Verdana" panose="020B0604030504040204" pitchFamily="34" charset="0"/>
              </a:rPr>
              <a:t>Beneficial</a:t>
            </a:r>
            <a:r>
              <a:rPr lang="de-DE" sz="1400" b="1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400" b="1" dirty="0" err="1">
                <a:latin typeface="Verdana" panose="020B0604030504040204" pitchFamily="34" charset="0"/>
                <a:ea typeface="Verdana" panose="020B0604030504040204" pitchFamily="34" charset="0"/>
              </a:rPr>
              <a:t>factors</a:t>
            </a:r>
            <a:endParaRPr lang="de-DE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7E302589-0AC6-4217-873C-696D787838A7}"/>
              </a:ext>
            </a:extLst>
          </p:cNvPr>
          <p:cNvSpPr txBox="1"/>
          <p:nvPr/>
        </p:nvSpPr>
        <p:spPr>
          <a:xfrm>
            <a:off x="6626293" y="3120853"/>
            <a:ext cx="17186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400" b="1" dirty="0" err="1">
                <a:latin typeface="Verdana" panose="020B0604030504040204" pitchFamily="34" charset="0"/>
                <a:ea typeface="Verdana" panose="020B0604030504040204" pitchFamily="34" charset="0"/>
              </a:rPr>
              <a:t>Unvafourable</a:t>
            </a:r>
            <a:r>
              <a:rPr lang="de-DE" sz="1400" b="1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400" b="1" dirty="0" err="1">
                <a:latin typeface="Verdana" panose="020B0604030504040204" pitchFamily="34" charset="0"/>
                <a:ea typeface="Verdana" panose="020B0604030504040204" pitchFamily="34" charset="0"/>
              </a:rPr>
              <a:t>factors</a:t>
            </a:r>
            <a:endParaRPr lang="de-DE" sz="1400" b="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559C4D43-348E-4796-829B-B21095487137}"/>
              </a:ext>
            </a:extLst>
          </p:cNvPr>
          <p:cNvSpPr/>
          <p:nvPr/>
        </p:nvSpPr>
        <p:spPr>
          <a:xfrm>
            <a:off x="3677893" y="5968908"/>
            <a:ext cx="1069310" cy="2842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>
                <a:solidFill>
                  <a:srgbClr val="FF0000"/>
                </a:solidFill>
              </a:rPr>
              <a:t>Score +2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1E8516FE-EBFF-4937-94FC-BFAAD4747B9D}"/>
              </a:ext>
            </a:extLst>
          </p:cNvPr>
          <p:cNvSpPr/>
          <p:nvPr/>
        </p:nvSpPr>
        <p:spPr>
          <a:xfrm>
            <a:off x="6908499" y="2763317"/>
            <a:ext cx="1069310" cy="2842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>
                <a:solidFill>
                  <a:srgbClr val="FF0000"/>
                </a:solidFill>
              </a:rPr>
              <a:t>Score -2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9B9B86D8-F1F5-465A-BDFC-E9DBBFFBA3A6}"/>
              </a:ext>
            </a:extLst>
          </p:cNvPr>
          <p:cNvSpPr txBox="1"/>
          <p:nvPr/>
        </p:nvSpPr>
        <p:spPr>
          <a:xfrm>
            <a:off x="9008668" y="2611835"/>
            <a:ext cx="2431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1400" b="1" dirty="0">
                <a:latin typeface="Verdana" panose="020B0604030504040204" pitchFamily="34" charset="0"/>
                <a:ea typeface="Verdana" panose="020B0604030504040204" pitchFamily="34" charset="0"/>
              </a:rPr>
              <a:t>TNBC Patient Scoring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B3564C92-85AA-4906-958D-28099801B24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887"/>
          <a:stretch/>
        </p:blipFill>
        <p:spPr>
          <a:xfrm>
            <a:off x="6830435" y="3646348"/>
            <a:ext cx="1417634" cy="2009690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0CB98D97-FB3B-40B7-A103-C6A855EFC3C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12"/>
          <a:stretch/>
        </p:blipFill>
        <p:spPr>
          <a:xfrm>
            <a:off x="3457201" y="2804460"/>
            <a:ext cx="1430261" cy="2009690"/>
          </a:xfrm>
          <a:prstGeom prst="rect">
            <a:avLst/>
          </a:prstGeom>
        </p:spPr>
      </p:pic>
      <p:graphicFrame>
        <p:nvGraphicFramePr>
          <p:cNvPr id="41" name="Objekt 40">
            <a:extLst>
              <a:ext uri="{FF2B5EF4-FFF2-40B4-BE49-F238E27FC236}">
                <a16:creationId xmlns:a16="http://schemas.microsoft.com/office/drawing/2014/main" id="{6CD4C05B-A0DA-48D1-9C6C-E4298F5035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4460567"/>
              </p:ext>
            </p:extLst>
          </p:nvPr>
        </p:nvGraphicFramePr>
        <p:xfrm>
          <a:off x="8945563" y="2788686"/>
          <a:ext cx="2593975" cy="1976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8" name="Prism 8" r:id="rId9" imgW="4222951" imgH="3215455" progId="Prism8.Document">
                  <p:embed/>
                </p:oleObj>
              </mc:Choice>
              <mc:Fallback>
                <p:oleObj name="Prism 8" r:id="rId9" imgW="4222951" imgH="3215455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9E5F307-3CB5-43C0-BA17-3F4569EFC1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945563" y="2788686"/>
                        <a:ext cx="2593975" cy="1976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id="{204DBA55-6FE6-44CC-9E1D-19A4B09FBC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9189707"/>
              </p:ext>
            </p:extLst>
          </p:nvPr>
        </p:nvGraphicFramePr>
        <p:xfrm>
          <a:off x="8940800" y="4574071"/>
          <a:ext cx="2603500" cy="1976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9" name="Prism 8" r:id="rId11" imgW="4232315" imgH="3215455" progId="Prism8.Document">
                  <p:embed/>
                </p:oleObj>
              </mc:Choice>
              <mc:Fallback>
                <p:oleObj name="Prism 8" r:id="rId11" imgW="4232315" imgH="321545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940800" y="4574071"/>
                        <a:ext cx="2603500" cy="1976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27859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Verdana</vt:lpstr>
      <vt:lpstr>Office</vt:lpstr>
      <vt:lpstr>Prism 8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atement: text text text text text text text text text text text text text text text text text text.</dc:title>
  <dc:creator>Lenovo</dc:creator>
  <cp:lastModifiedBy>Anja Wege</cp:lastModifiedBy>
  <cp:revision>56</cp:revision>
  <dcterms:created xsi:type="dcterms:W3CDTF">2024-05-28T13:05:45Z</dcterms:created>
  <dcterms:modified xsi:type="dcterms:W3CDTF">2025-02-07T10:48:39Z</dcterms:modified>
</cp:coreProperties>
</file>